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BEF095-4AF5-4077-94B1-F6DD3E91058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10171C-B7C5-4508-944F-8D82C652E01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57165C-1182-4CF6-9704-36181488EAC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B9513A-BCAF-4FAD-971E-6FBD97E12FD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97FDC2-FF28-4EB4-BC76-807C6A4011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527A8A-2CBD-42B4-A5EE-D0F73D0504F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1EB09A-8F17-4D06-A5C7-5EBEDC90F6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BEEAB1-FEC6-4A58-BEA7-8B51A800DA8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0E80F4-E1F4-4626-B825-5835BF65418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4DE543-95BA-47AA-9CB2-F3AC24BECA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1D9A4C-9AEF-46BF-AD0B-9B63263AE6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E161FB-61E0-429B-BBBD-116B185347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A3F57D6-4861-4BA9-A7BA-517BAE3F90B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2"/>
          <p:cNvSpPr/>
          <p:nvPr/>
        </p:nvSpPr>
        <p:spPr>
          <a:xfrm>
            <a:off x="652320" y="0"/>
            <a:ext cx="620568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2" name="Object 2"/>
          <p:cNvGraphicFramePr/>
          <p:nvPr/>
        </p:nvGraphicFramePr>
        <p:xfrm>
          <a:off x="609480" y="228600"/>
          <a:ext cx="4954680" cy="78008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3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09480" y="228600"/>
                    <a:ext cx="4954680" cy="7800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4" name="TextBox 5"/>
          <p:cNvSpPr/>
          <p:nvPr/>
        </p:nvSpPr>
        <p:spPr>
          <a:xfrm>
            <a:off x="457200" y="7924680"/>
            <a:ext cx="586728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dditional File. Figure S1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. (A) Relationship between number of ESTs per contig and mean contig length or % of contigs with homologs in Arabidopsis.  Open symbols - mean contig length.  Closed symbols - homologs in Arabidopsis as assessed by BLASTX analysis against the NCBI nr Arabidopsis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database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.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) Gene ontology (GO) assignment of contigs with putative homologs in Arabidopsis 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13T21:27:50Z</dcterms:created>
  <dc:creator>Rebecca Grumet</dc:creator>
  <dc:description/>
  <dc:language>en-US</dc:language>
  <cp:lastModifiedBy>Rebecca Grumet</cp:lastModifiedBy>
  <dcterms:modified xsi:type="dcterms:W3CDTF">2012-04-17T18:52:03Z</dcterms:modified>
  <cp:revision>6</cp:revision>
  <dc:subject/>
  <dc:title>Slide 1</dc:title>
</cp:coreProperties>
</file>